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B78C37D-F01A-48EE-9415-BF53D1FA7B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C1F48B1-C973-4AE9-A744-F98505B8D8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C1E19B7-C04B-4AAB-9EB0-A274EDFB4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16C7A4-4884-46E1-827E-8535FD305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0263ED9-F10C-4701-90C4-CA46525D9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75644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07C80C-AC04-4B85-87A8-03F9362F2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708A653-8BC3-4C59-B160-79CD5E8976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5149B9F-369D-4452-BDF5-72A5A11E1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9E068FA-B32E-4308-9790-00F9ACABD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9007CA5-37E6-4094-BBB6-8412E5DC9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832682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800C720D-CCF4-4E84-94E2-3ADBF935B6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F4E8EEB-0E1D-4CE5-8DF4-A3A2A16FA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684BF6A-2E66-4735-9BB3-2DEFBFF86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5C1388-42AF-449A-9FA5-1876D40B2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492FAB9-EDFF-4EB6-89D5-A60CF13B7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57578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7E82A9A-861D-41C4-AA24-E27BEA790B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6C9532A-14D6-427B-A422-A47FF614A7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FD66D84-37AF-4380-8CBF-396F149D5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1E419B6-C332-4E98-94A6-C73555AB3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D9DFDA8-2CBB-444D-93C8-9BF978CD1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4469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F97D037-C058-41A2-BE9A-18EEDAD55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AF41DB1-7579-4657-A080-485390DDE9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6E803F2-AEF9-4DB8-A9F8-DDE13DD68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F993837-E812-4487-8AC3-E36C8BAEE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EA31F5E-3338-465A-8178-1919A976A6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08759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08A868-C3DB-4458-A2FA-BF92FC46E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DBA90D-B6BC-4DA2-A50E-5B9232CEA9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19D6946-BEE0-4610-BD43-9DD0DBCBCA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CE12F37-AEB9-485B-8D12-8F2D9431B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035D511-339E-4C05-A905-2251EC5295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9B2BE62B-D6BA-4795-927F-457B71CD0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985520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B23AF02-0AD4-4397-99B8-6016A3059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E59E250-7E12-49CE-9E00-86D9A3ACC5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353A36AF-5D35-4CF7-A7FA-FBC4278412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72A5E65A-7331-484D-8EAA-B7ADEE069D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34B4FB2-62CF-46AB-8308-9F099143C3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63E39C4-80B1-4FCC-A2F2-84304E7F25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2E9FE66A-1A9E-4C63-8F34-101DF11F37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93EE281-8126-446F-BCF0-5A6415C82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660021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5F1725-8246-4965-BC0C-B858419D7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94D8B060-114A-4614-B73B-9F8DF673F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2AC0A6D1-0BE9-4816-9AA2-EC7399CFA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586C3DB-810A-4AC1-AD33-2E422564D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25033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6ECF1041-D862-4379-8B15-3EB70AA9A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0C1D7056-1B7D-421E-B5C7-E0F720782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EBA0DEE-C6C4-47D4-B7A4-C601AFBA5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17522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2DD5654-7C9D-4830-B7F2-34079480C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F724288-D011-42E6-AB93-444BB319C5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CDF5FC7-E374-4187-BCA4-9D607862F7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F1D5071C-384A-4237-8738-C9F45BFD6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1EFEA7B-154E-4637-87FA-C165BB961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DE79313-0DCD-4959-822B-AB2608E9C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7444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16E4E4A-B850-48C8-973E-5718A125DF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BA937653-3D17-4316-8941-B816032268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B1A023FA-C8AE-4A63-8A97-D5EB6AFF4D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E3BB9563-4B9B-4CEB-A3AB-4FC01ECB2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7D46FB1-E611-425F-B271-E1204D192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5E766A4-2664-4F5F-9B83-0056E6C72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623296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E6B423A-8F69-41B7-A64D-73A823CBA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5ED15B9-9C6D-45A3-9FA5-108FCCB843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B199B47-D44C-4780-BB98-C4E32B4EAD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FA98-652E-4258-835A-B81DCFDBC90E}" type="datetimeFigureOut">
              <a:rPr lang="es-CO" smtClean="0"/>
              <a:t>16/01/2020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E43EA3A-A670-40AB-8EBA-684B8CD02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3FDED2D-4089-4762-95CF-277D6497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08594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889F3E59-4C26-44ED-B118-567AA55562D6}"/>
              </a:ext>
            </a:extLst>
          </p:cNvPr>
          <p:cNvGrpSpPr/>
          <p:nvPr/>
        </p:nvGrpSpPr>
        <p:grpSpPr>
          <a:xfrm>
            <a:off x="344557" y="471191"/>
            <a:ext cx="11203976" cy="5571066"/>
            <a:chOff x="344557" y="471191"/>
            <a:chExt cx="11203976" cy="5571066"/>
          </a:xfrm>
        </p:grpSpPr>
        <p:pic>
          <p:nvPicPr>
            <p:cNvPr id="16" name="Imagen 15">
              <a:extLst>
                <a:ext uri="{FF2B5EF4-FFF2-40B4-BE49-F238E27FC236}">
                  <a16:creationId xmlns:a16="http://schemas.microsoft.com/office/drawing/2014/main" id="{EA065371-B5C8-45DB-BBF2-57B71F0B63BD}"/>
                </a:ext>
              </a:extLst>
            </p:cNvPr>
            <p:cNvPicPr/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" b="3154"/>
            <a:stretch/>
          </p:blipFill>
          <p:spPr bwMode="auto">
            <a:xfrm>
              <a:off x="643467" y="471191"/>
              <a:ext cx="10905066" cy="5571066"/>
            </a:xfrm>
            <a:prstGeom prst="rect">
              <a:avLst/>
            </a:prstGeom>
            <a:noFill/>
          </p:spPr>
        </p:pic>
        <p:sp>
          <p:nvSpPr>
            <p:cNvPr id="4" name="CuadroTexto 3">
              <a:extLst>
                <a:ext uri="{FF2B5EF4-FFF2-40B4-BE49-F238E27FC236}">
                  <a16:creationId xmlns:a16="http://schemas.microsoft.com/office/drawing/2014/main" id="{490D14C6-2E6A-4CFF-B69A-524D644995D1}"/>
                </a:ext>
              </a:extLst>
            </p:cNvPr>
            <p:cNvSpPr txBox="1"/>
            <p:nvPr/>
          </p:nvSpPr>
          <p:spPr>
            <a:xfrm>
              <a:off x="344557" y="471191"/>
              <a:ext cx="317716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CO" dirty="0"/>
                <a:t>A</a:t>
              </a:r>
            </a:p>
          </p:txBody>
        </p:sp>
        <p:cxnSp>
          <p:nvCxnSpPr>
            <p:cNvPr id="7" name="Conector recto de flecha 6">
              <a:extLst>
                <a:ext uri="{FF2B5EF4-FFF2-40B4-BE49-F238E27FC236}">
                  <a16:creationId xmlns:a16="http://schemas.microsoft.com/office/drawing/2014/main" id="{2322F6D0-D861-424E-AEB3-5BFDA4141E31}"/>
                </a:ext>
              </a:extLst>
            </p:cNvPr>
            <p:cNvCxnSpPr>
              <a:cxnSpLocks/>
            </p:cNvCxnSpPr>
            <p:nvPr/>
          </p:nvCxnSpPr>
          <p:spPr>
            <a:xfrm>
              <a:off x="9926081" y="3277313"/>
              <a:ext cx="0" cy="225287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ector recto de flecha 9">
              <a:extLst>
                <a:ext uri="{FF2B5EF4-FFF2-40B4-BE49-F238E27FC236}">
                  <a16:creationId xmlns:a16="http://schemas.microsoft.com/office/drawing/2014/main" id="{BA0D50C4-B68D-4275-B930-3AC50204C21C}"/>
                </a:ext>
              </a:extLst>
            </p:cNvPr>
            <p:cNvCxnSpPr>
              <a:cxnSpLocks/>
            </p:cNvCxnSpPr>
            <p:nvPr/>
          </p:nvCxnSpPr>
          <p:spPr>
            <a:xfrm>
              <a:off x="3213446" y="4934958"/>
              <a:ext cx="0" cy="225287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317234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o 11">
            <a:extLst>
              <a:ext uri="{FF2B5EF4-FFF2-40B4-BE49-F238E27FC236}">
                <a16:creationId xmlns:a16="http://schemas.microsoft.com/office/drawing/2014/main" id="{00967BF3-E0E4-4D37-BD29-C00945AABA53}"/>
              </a:ext>
            </a:extLst>
          </p:cNvPr>
          <p:cNvGrpSpPr/>
          <p:nvPr/>
        </p:nvGrpSpPr>
        <p:grpSpPr>
          <a:xfrm>
            <a:off x="344557" y="471191"/>
            <a:ext cx="9965633" cy="5382957"/>
            <a:chOff x="344557" y="471191"/>
            <a:chExt cx="9965633" cy="5382957"/>
          </a:xfrm>
        </p:grpSpPr>
        <p:pic>
          <p:nvPicPr>
            <p:cNvPr id="4" name="Imagen 3">
              <a:extLst>
                <a:ext uri="{FF2B5EF4-FFF2-40B4-BE49-F238E27FC236}">
                  <a16:creationId xmlns:a16="http://schemas.microsoft.com/office/drawing/2014/main" id="{C34F904E-BC92-4830-BB03-2E8632EEFF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4" t="10207" r="1367" b="14624"/>
            <a:stretch/>
          </p:blipFill>
          <p:spPr>
            <a:xfrm>
              <a:off x="1166190" y="1003851"/>
              <a:ext cx="9144000" cy="4850297"/>
            </a:xfrm>
            <a:prstGeom prst="rect">
              <a:avLst/>
            </a:prstGeom>
          </p:spPr>
        </p:pic>
        <p:sp>
          <p:nvSpPr>
            <p:cNvPr id="5" name="CuadroTexto 4">
              <a:extLst>
                <a:ext uri="{FF2B5EF4-FFF2-40B4-BE49-F238E27FC236}">
                  <a16:creationId xmlns:a16="http://schemas.microsoft.com/office/drawing/2014/main" id="{D55B714D-3994-4580-A452-047D00AE4174}"/>
                </a:ext>
              </a:extLst>
            </p:cNvPr>
            <p:cNvSpPr txBox="1"/>
            <p:nvPr/>
          </p:nvSpPr>
          <p:spPr>
            <a:xfrm>
              <a:off x="1404316" y="1014098"/>
              <a:ext cx="88216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700" dirty="0">
                  <a:solidFill>
                    <a:schemeClr val="bg1"/>
                  </a:solidFill>
                </a:rPr>
                <a:t>R1   R2    R3    </a:t>
              </a:r>
              <a:r>
                <a:rPr lang="es-CO" sz="700" dirty="0" err="1">
                  <a:solidFill>
                    <a:schemeClr val="bg1"/>
                  </a:solidFill>
                </a:rPr>
                <a:t>F.s</a:t>
              </a:r>
              <a:r>
                <a:rPr lang="es-CO" sz="700" dirty="0">
                  <a:solidFill>
                    <a:schemeClr val="bg1"/>
                  </a:solidFill>
                </a:rPr>
                <a:t>     1       2      3       4      5       6      7       8      9     10     11    12     13    14    15     16    17    18     19    20    21    22     23    24     25    26     27   28     29    30     31    32    33    34     35    36     37    38    39    40     41    42    43    44 </a:t>
              </a:r>
            </a:p>
          </p:txBody>
        </p: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2701F862-A17C-4387-8167-0FC041CC7D48}"/>
                </a:ext>
              </a:extLst>
            </p:cNvPr>
            <p:cNvSpPr txBox="1"/>
            <p:nvPr/>
          </p:nvSpPr>
          <p:spPr>
            <a:xfrm>
              <a:off x="1425747" y="2613141"/>
              <a:ext cx="88216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700" dirty="0">
                  <a:solidFill>
                    <a:schemeClr val="bg1"/>
                  </a:solidFill>
                </a:rPr>
                <a:t>45     46    47    48     49    50    51    52    53     54     55    56    57    58    59     60    61    62     63    64    65     66    67    68     69    70    71     72    73    74     75    76    77     78    79     80    81    82    83     84    85     86    87    88    89     90     91   92     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2901584F-7361-4B62-874E-C488DC38E5E1}"/>
                </a:ext>
              </a:extLst>
            </p:cNvPr>
            <p:cNvSpPr txBox="1"/>
            <p:nvPr/>
          </p:nvSpPr>
          <p:spPr>
            <a:xfrm>
              <a:off x="1404316" y="4252694"/>
              <a:ext cx="88216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700" dirty="0">
                  <a:solidFill>
                    <a:schemeClr val="bg1"/>
                  </a:solidFill>
                </a:rPr>
                <a:t>93    94     95    96     97   98     99  100   101  102  103   104  105  106  107  108  109  110  111   112   113  115  116  117  118  119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FCED0C52-7985-461B-81D2-FB481BD14BA7}"/>
                </a:ext>
              </a:extLst>
            </p:cNvPr>
            <p:cNvSpPr txBox="1"/>
            <p:nvPr/>
          </p:nvSpPr>
          <p:spPr>
            <a:xfrm>
              <a:off x="344557" y="471191"/>
              <a:ext cx="309700" cy="369332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s-CO" dirty="0"/>
                <a:t>B</a:t>
              </a:r>
            </a:p>
          </p:txBody>
        </p:sp>
        <p:cxnSp>
          <p:nvCxnSpPr>
            <p:cNvPr id="11" name="Conector recto de flecha 10">
              <a:extLst>
                <a:ext uri="{FF2B5EF4-FFF2-40B4-BE49-F238E27FC236}">
                  <a16:creationId xmlns:a16="http://schemas.microsoft.com/office/drawing/2014/main" id="{CE9224CC-3D5D-47EA-8833-A768C2F59528}"/>
                </a:ext>
              </a:extLst>
            </p:cNvPr>
            <p:cNvCxnSpPr>
              <a:cxnSpLocks/>
            </p:cNvCxnSpPr>
            <p:nvPr/>
          </p:nvCxnSpPr>
          <p:spPr>
            <a:xfrm>
              <a:off x="1541736" y="1687663"/>
              <a:ext cx="0" cy="225287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5126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42B39FC4-A7FD-4945-AA85-8A22525663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406" t="12796" r="2898" b="16580"/>
          <a:stretch/>
        </p:blipFill>
        <p:spPr>
          <a:xfrm>
            <a:off x="1245705" y="182217"/>
            <a:ext cx="9144000" cy="4823791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1DD70B16-0A06-4C8F-A976-6456C3D0861D}"/>
              </a:ext>
            </a:extLst>
          </p:cNvPr>
          <p:cNvSpPr txBox="1"/>
          <p:nvPr/>
        </p:nvSpPr>
        <p:spPr>
          <a:xfrm>
            <a:off x="1533837" y="243158"/>
            <a:ext cx="88216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700" dirty="0">
                <a:solidFill>
                  <a:schemeClr val="bg1"/>
                </a:solidFill>
              </a:rPr>
              <a:t>R1   R2     R3    </a:t>
            </a:r>
            <a:r>
              <a:rPr lang="es-CO" sz="700" dirty="0" err="1">
                <a:solidFill>
                  <a:schemeClr val="bg1"/>
                </a:solidFill>
              </a:rPr>
              <a:t>F.s</a:t>
            </a:r>
            <a:r>
              <a:rPr lang="es-CO" sz="700" dirty="0">
                <a:solidFill>
                  <a:schemeClr val="bg1"/>
                </a:solidFill>
              </a:rPr>
              <a:t>     1       2      3       4      5       6       7       8      9     10     11    12     13    14    15     16    17    18     19     20    21    22     23    24     25    26     27   28     29    30     31    32    33    34     35    36     37    38    39    40     41    42    43    44 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D1AC4FF2-D198-4114-A06D-C7B11162280E}"/>
              </a:ext>
            </a:extLst>
          </p:cNvPr>
          <p:cNvSpPr txBox="1"/>
          <p:nvPr/>
        </p:nvSpPr>
        <p:spPr>
          <a:xfrm>
            <a:off x="1469543" y="1733822"/>
            <a:ext cx="88216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700" dirty="0">
                <a:solidFill>
                  <a:schemeClr val="bg1"/>
                </a:solidFill>
              </a:rPr>
              <a:t>45    46     47    48     49    50     51    52    53     54    55     56    57    58     59     60    61    62     63    64     65    66     67    68    69     70    71     72    73    74     75    76    77     78    79     80    81    82     83    84    85     86    87    88    89     90     91   92  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C6BAEED-77B2-4151-B949-EA737845962E}"/>
              </a:ext>
            </a:extLst>
          </p:cNvPr>
          <p:cNvSpPr txBox="1"/>
          <p:nvPr/>
        </p:nvSpPr>
        <p:spPr>
          <a:xfrm>
            <a:off x="1502881" y="3365073"/>
            <a:ext cx="88216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700" dirty="0">
                <a:solidFill>
                  <a:schemeClr val="bg1"/>
                </a:solidFill>
              </a:rPr>
              <a:t>93    94     95    96    97    98     99   100   101  102  103   104  105  106  107  108  109  110  111   112   113  115  116  117  118  119   120   Cl-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D72CCFB2-E0BA-44BB-8AFD-8F1912ACFA3B}"/>
              </a:ext>
            </a:extLst>
          </p:cNvPr>
          <p:cNvSpPr txBox="1"/>
          <p:nvPr/>
        </p:nvSpPr>
        <p:spPr>
          <a:xfrm>
            <a:off x="344557" y="471191"/>
            <a:ext cx="308098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s-CO" dirty="0"/>
              <a:t>C</a:t>
            </a:r>
          </a:p>
        </p:txBody>
      </p:sp>
      <p:cxnSp>
        <p:nvCxnSpPr>
          <p:cNvPr id="10" name="Conector recto de flecha 9">
            <a:extLst>
              <a:ext uri="{FF2B5EF4-FFF2-40B4-BE49-F238E27FC236}">
                <a16:creationId xmlns:a16="http://schemas.microsoft.com/office/drawing/2014/main" id="{D7673B84-6BAA-475E-AB37-149072518C54}"/>
              </a:ext>
            </a:extLst>
          </p:cNvPr>
          <p:cNvCxnSpPr>
            <a:cxnSpLocks/>
          </p:cNvCxnSpPr>
          <p:nvPr/>
        </p:nvCxnSpPr>
        <p:spPr>
          <a:xfrm>
            <a:off x="1823087" y="3919535"/>
            <a:ext cx="0" cy="225287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Conector recto de flecha 10">
            <a:extLst>
              <a:ext uri="{FF2B5EF4-FFF2-40B4-BE49-F238E27FC236}">
                <a16:creationId xmlns:a16="http://schemas.microsoft.com/office/drawing/2014/main" id="{3B02D112-8FDD-4DFB-B9F6-6023FB8F34DD}"/>
              </a:ext>
            </a:extLst>
          </p:cNvPr>
          <p:cNvCxnSpPr>
            <a:cxnSpLocks/>
          </p:cNvCxnSpPr>
          <p:nvPr/>
        </p:nvCxnSpPr>
        <p:spPr>
          <a:xfrm>
            <a:off x="3792563" y="3919535"/>
            <a:ext cx="0" cy="225287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tángulo 1">
            <a:extLst>
              <a:ext uri="{FF2B5EF4-FFF2-40B4-BE49-F238E27FC236}">
                <a16:creationId xmlns:a16="http://schemas.microsoft.com/office/drawing/2014/main" id="{1A86FDC5-B1CB-4E1C-9077-87A41B2DD71A}"/>
              </a:ext>
            </a:extLst>
          </p:cNvPr>
          <p:cNvSpPr/>
          <p:nvPr/>
        </p:nvSpPr>
        <p:spPr>
          <a:xfrm>
            <a:off x="1823087" y="5290788"/>
            <a:ext cx="769951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S4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. PCR results for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IX1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IX4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and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SIX3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for the 120 fungal isolates. (A) the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IX1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gene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pecific of </a:t>
            </a:r>
            <a:r>
              <a:rPr lang="en-US" sz="1400" i="1" dirty="0" err="1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(Table 1) on 2 out of 120 fungal isolates collected in this study (Table 2). (B) no amplification of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IX4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gene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on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120 fungal isolates. </a:t>
            </a:r>
            <a:r>
              <a:rPr lang="en-US" sz="1400">
                <a:latin typeface="Palatino Linotype" panose="02040502050505030304" pitchFamily="18" charset="0"/>
                <a:ea typeface="Times New Roman" panose="02020603050405020304" pitchFamily="18" charset="0"/>
              </a:rPr>
              <a:t>(C)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The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IX3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gene amplified on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59 and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-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UDC10 out of 120 fungal isolates. Positive bands are indicated by white arrows. Control DNA: R1=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004, R2=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007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,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R3=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ol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1943. PCR product visualization was carried out following electrophoresis in a 1% agarose gel.  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endParaRPr lang="es-CO" sz="14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2446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366</Words>
  <Application>Microsoft Office PowerPoint</Application>
  <PresentationFormat>Panorámica</PresentationFormat>
  <Paragraphs>10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ema de Offic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Soto Suárez</dc:creator>
  <cp:lastModifiedBy>Mauricio Soto Suárez</cp:lastModifiedBy>
  <cp:revision>16</cp:revision>
  <dcterms:created xsi:type="dcterms:W3CDTF">2019-03-04T18:45:41Z</dcterms:created>
  <dcterms:modified xsi:type="dcterms:W3CDTF">2020-01-17T00:29:01Z</dcterms:modified>
</cp:coreProperties>
</file>